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1DEE0D1-2E80-41C4-9D0D-28CD28168D4C}" v="3" dt="2025-08-22T08:17:50.35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1" autoAdjust="0"/>
    <p:restoredTop sz="94660"/>
  </p:normalViewPr>
  <p:slideViewPr>
    <p:cSldViewPr snapToGrid="0">
      <p:cViewPr>
        <p:scale>
          <a:sx n="100" d="100"/>
          <a:sy n="100" d="100"/>
        </p:scale>
        <p:origin x="-4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2FABD1-A5A6-4822-BE18-6A5484831B74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0B6206-626F-4889-A30E-6C62684660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68942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0B6206-626F-4889-A30E-6C626846604B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30650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88DBF8-6D14-84F6-9562-792FC5173B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9BE90A2-2F0D-BDC9-CD9C-3F133B2820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F3ADC5-019D-8DE7-7A88-7C527F6110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F1169-CF27-4D4B-9C44-E87C395E56A5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A0CBBA-A508-AA7A-BBCC-622D9AF496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EAC231-3AE5-462A-556F-FB1381CBC7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08E06-89AF-4605-930E-F6FA459ED3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8332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9312E7-3A38-C971-2D1A-B851C30F93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4714FA-CE6B-CDE3-9BE1-4AA8E781C4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F7A542-CCD4-8CDC-1A05-0AC1FD3453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F1169-CF27-4D4B-9C44-E87C395E56A5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A6B150-7478-B414-DF90-2792B11B46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24582-CBE1-31DA-11A2-52FF2705AE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08E06-89AF-4605-930E-F6FA459ED3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1466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1ED6A4A-0523-C5BA-42F1-4CDF67FD7F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4FA87C-5009-2E96-E4C1-0CBAE751D5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C41DF3-70F0-8F4F-676D-87BCDECB65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F1169-CF27-4D4B-9C44-E87C395E56A5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0F49AF-A687-F81E-2698-30C782BE0D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B9D4FE-D7DC-8FAC-BB52-A324BB28CF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08E06-89AF-4605-930E-F6FA459ED3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35130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0F0DB2-F3F9-B6B7-358C-606CE4FA9F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DFA57E-E6F2-D655-48BB-7A96723128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B2F502-992D-D689-1C23-422BC627ED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F1169-CF27-4D4B-9C44-E87C395E56A5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C97498-F5D6-C70F-1062-3F8CDDF56E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835AFD-E0A9-7746-FA9C-7D97CC1A88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08E06-89AF-4605-930E-F6FA459ED3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88899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783B44-BA40-E4BB-224F-9290D57496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572FEA-3F5E-6B2D-F3B8-933C1CE166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B5E936-91C8-5FD7-71BD-73FCA47E10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F1169-CF27-4D4B-9C44-E87C395E56A5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164062-B192-BCDC-3092-C7D46A9B1B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434DAC-AE6E-7D04-96E8-64F20F8C22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08E06-89AF-4605-930E-F6FA459ED3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61068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950D19-A2ED-775E-6683-64A9E33C25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496E78-EC89-0F0F-FD47-386D4E9ED94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291626-8BBD-5D47-560D-884EA1C13F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3B50DA-5232-24DF-251A-B5EF8E91CF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F1169-CF27-4D4B-9C44-E87C395E56A5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7EC53A-C370-8841-58DE-9437BC1B8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BA9B9F-2D55-85E1-BB85-05853206B6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08E06-89AF-4605-930E-F6FA459ED3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75047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EE293-C3E5-C9F3-F72F-753ED11439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D004D5-4E9A-7B74-F4A6-12EE9C9463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894E98-7A77-0FF9-B69D-3DCD9A1F74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C335DE3-3808-A779-CAE5-170E4E4728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5BF0823-F1F2-AF28-5440-EF6C1DCE77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2F2108-020A-CE2C-5BAC-73A81517C9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F1169-CF27-4D4B-9C44-E87C395E56A5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7E9E0A-BB8E-6262-95F6-91145423A1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FCFA102-4776-D1CA-1DE6-A8EF29207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08E06-89AF-4605-930E-F6FA459ED3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6597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D7B9CA-3674-F259-E607-6DDCD04C0C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3EA60DE-9DE0-4EF8-2E1F-BB9E00DF5A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F1169-CF27-4D4B-9C44-E87C395E56A5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2C6B984-DA02-FC6C-1904-DFED2C541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18DEFF7-D862-3600-2B0C-4194F2CB60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08E06-89AF-4605-930E-F6FA459ED3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6475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7A4386-DF25-5AD4-C290-97AA0AD67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F1169-CF27-4D4B-9C44-E87C395E56A5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BB4A8E-D039-A439-EA7B-7762F571C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C880160-43DA-D89E-A488-7DDBA8621A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08E06-89AF-4605-930E-F6FA459ED3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1110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7513C3-D1C2-DBE7-2B77-885154830A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2C8913-6747-3DA4-5B06-0D31AB5F0F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13D0039-1789-24E8-08F8-91DE13C649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24DF08-FB4B-C06E-FD9E-427320602A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F1169-CF27-4D4B-9C44-E87C395E56A5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A3CCC8-3A8D-B378-F360-C8A74063D1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84D58A-49CC-5DA3-1DB3-5A6CB93638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08E06-89AF-4605-930E-F6FA459ED3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78309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FB97B2-76B7-3B6C-6E2A-6829717F2E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3630223-C48F-174F-E4D2-089E6FBFD77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129362-2E52-18AF-46B3-9659B59E90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61C4CB-EEA9-4EFD-9C94-4D3E3E18E6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F1169-CF27-4D4B-9C44-E87C395E56A5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4470ED-A9DE-1C81-B03E-253CB60E69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9E150A-5CEC-613E-E933-8916A41A7F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08E06-89AF-4605-930E-F6FA459ED3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72102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FABA808-00B6-CC86-0127-B0BD2DD613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0998A4-6F42-40A7-D1B8-5F35D2252A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D58CB4-86FA-6556-2D2D-4D8435BD009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5CF1169-CF27-4D4B-9C44-E87C395E56A5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4EEF81-C1D1-D538-2B61-04AF4F9F58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FAEA92-765D-36CD-DA11-A3575B1BC4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1D08E06-89AF-4605-930E-F6FA459ED3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47613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B2C570AD-9046-E206-EDBF-F8C3BDF5BEA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99943" y="758045"/>
            <a:ext cx="6192114" cy="582058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96CFF6F-6AA1-A433-4691-1B7E6BFBB4FB}"/>
              </a:ext>
            </a:extLst>
          </p:cNvPr>
          <p:cNvSpPr txBox="1"/>
          <p:nvPr/>
        </p:nvSpPr>
        <p:spPr>
          <a:xfrm>
            <a:off x="708355" y="55094"/>
            <a:ext cx="107752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venir Next LT Pro" panose="020B0504020202020204" pitchFamily="34" charset="0"/>
              </a:rPr>
              <a:t>Figure S2a. Forest plot of meta-analysis of incidence at 1 hour for Tracheal Tube studies</a:t>
            </a:r>
          </a:p>
        </p:txBody>
      </p:sp>
    </p:spTree>
    <p:extLst>
      <p:ext uri="{BB962C8B-B14F-4D97-AF65-F5344CB8AC3E}">
        <p14:creationId xmlns:p14="http://schemas.microsoft.com/office/powerpoint/2010/main" val="22626139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469BF07-0DE4-B48F-861F-8CD9EAF0D4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43200" y="564596"/>
            <a:ext cx="6880260" cy="634543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EE299A1-4447-13AA-84DF-BFFA716F714C}"/>
              </a:ext>
            </a:extLst>
          </p:cNvPr>
          <p:cNvSpPr txBox="1"/>
          <p:nvPr/>
        </p:nvSpPr>
        <p:spPr>
          <a:xfrm>
            <a:off x="795685" y="0"/>
            <a:ext cx="107752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venir Next LT Pro" panose="020B0504020202020204" pitchFamily="34" charset="0"/>
              </a:rPr>
              <a:t>Figure S2b. Forest plot of meta-analysis of incidence at 24 hours for Tracheal Tube studies</a:t>
            </a:r>
          </a:p>
        </p:txBody>
      </p:sp>
    </p:spTree>
    <p:extLst>
      <p:ext uri="{BB962C8B-B14F-4D97-AF65-F5344CB8AC3E}">
        <p14:creationId xmlns:p14="http://schemas.microsoft.com/office/powerpoint/2010/main" val="982228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6B2001E-4AA1-6037-154A-25DBCC35C7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7225" y="988584"/>
            <a:ext cx="6379279" cy="583106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E5FD9EF-B440-D1C6-92C9-EC6719AEB903}"/>
              </a:ext>
            </a:extLst>
          </p:cNvPr>
          <p:cNvSpPr txBox="1"/>
          <p:nvPr/>
        </p:nvSpPr>
        <p:spPr>
          <a:xfrm>
            <a:off x="853767" y="38356"/>
            <a:ext cx="107752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venir Next LT Pro" panose="020B0504020202020204" pitchFamily="34" charset="0"/>
              </a:rPr>
              <a:t>Figure S2c. Forest plot of meta-analysis of incidence at 1 hour for Supraglottic Airway Device studies</a:t>
            </a:r>
          </a:p>
        </p:txBody>
      </p:sp>
    </p:spTree>
    <p:extLst>
      <p:ext uri="{BB962C8B-B14F-4D97-AF65-F5344CB8AC3E}">
        <p14:creationId xmlns:p14="http://schemas.microsoft.com/office/powerpoint/2010/main" val="11485591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7BEC970-F672-108A-4BEE-76F9B21294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22408" y="757068"/>
            <a:ext cx="6182588" cy="582058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7BB543A-B923-2D25-4B34-C8E751832998}"/>
              </a:ext>
            </a:extLst>
          </p:cNvPr>
          <p:cNvSpPr txBox="1"/>
          <p:nvPr/>
        </p:nvSpPr>
        <p:spPr>
          <a:xfrm>
            <a:off x="708355" y="110737"/>
            <a:ext cx="107752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venir Next LT Pro" panose="020B0504020202020204" pitchFamily="34" charset="0"/>
              </a:rPr>
              <a:t>Figure S2d. Forest plot of meta-analysis of incidence at 24 hours for Supraglottic Airway Device studies</a:t>
            </a:r>
          </a:p>
        </p:txBody>
      </p:sp>
    </p:spTree>
    <p:extLst>
      <p:ext uri="{BB962C8B-B14F-4D97-AF65-F5344CB8AC3E}">
        <p14:creationId xmlns:p14="http://schemas.microsoft.com/office/powerpoint/2010/main" val="3030081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7</Words>
  <Application>Microsoft Office PowerPoint</Application>
  <PresentationFormat>Widescreen</PresentationFormat>
  <Paragraphs>5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Avenir Next LT Pro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achary Moulder</dc:creator>
  <cp:lastModifiedBy>Rona Gloag</cp:lastModifiedBy>
  <cp:revision>3</cp:revision>
  <dcterms:created xsi:type="dcterms:W3CDTF">2025-07-25T14:07:05Z</dcterms:created>
  <dcterms:modified xsi:type="dcterms:W3CDTF">2025-10-06T13:15:49Z</dcterms:modified>
</cp:coreProperties>
</file>